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revisionInfo.xml" ContentType="application/vnd.ms-powerpoint.revisioninfo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ppt/changesInfos/changesInfo1.xml" ContentType="application/vnd.ms-powerpoint.changesinfo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61" r:id="rId2"/>
    <p:sldId id="264" r:id="rId3"/>
  </p:sldIdLst>
  <p:sldSz cx="7561263" cy="106934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3369">
          <p15:clr>
            <a:srgbClr val="A4A3A4"/>
          </p15:clr>
        </p15:guide>
        <p15:guide id="2" pos="242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F37FC8-971D-470F-AC09-B204BCBEE5A1}" v="1" dt="2021-07-29T12:05:36.980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9629" autoAdjust="0"/>
  </p:normalViewPr>
  <p:slideViewPr>
    <p:cSldViewPr>
      <p:cViewPr>
        <p:scale>
          <a:sx n="72" d="100"/>
          <a:sy n="72" d="100"/>
        </p:scale>
        <p:origin x="-917" y="182"/>
      </p:cViewPr>
      <p:guideLst>
        <p:guide orient="horz" pos="3369"/>
        <p:guide pos="242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Lingling" userId="bec88c83-2b4b-4a43-bc36-807232f649f0" providerId="ADAL" clId="{6CF37FC8-971D-470F-AC09-B204BCBEE5A1}"/>
    <pc:docChg chg="modSld">
      <pc:chgData name="Lingling" userId="bec88c83-2b4b-4a43-bc36-807232f649f0" providerId="ADAL" clId="{6CF37FC8-971D-470F-AC09-B204BCBEE5A1}" dt="2021-07-29T12:06:57.699" v="35" actId="20577"/>
      <pc:docMkLst>
        <pc:docMk/>
      </pc:docMkLst>
      <pc:sldChg chg="modSp mod">
        <pc:chgData name="Lingling" userId="bec88c83-2b4b-4a43-bc36-807232f649f0" providerId="ADAL" clId="{6CF37FC8-971D-470F-AC09-B204BCBEE5A1}" dt="2021-07-29T12:05:50.339" v="4" actId="20577"/>
        <pc:sldMkLst>
          <pc:docMk/>
          <pc:sldMk cId="0" sldId="261"/>
        </pc:sldMkLst>
        <pc:spChg chg="mod">
          <ac:chgData name="Lingling" userId="bec88c83-2b4b-4a43-bc36-807232f649f0" providerId="ADAL" clId="{6CF37FC8-971D-470F-AC09-B204BCBEE5A1}" dt="2021-07-29T12:05:50.339" v="4" actId="20577"/>
          <ac:spMkLst>
            <pc:docMk/>
            <pc:sldMk cId="0" sldId="261"/>
            <ac:spMk id="14" creationId="{00000000-0000-0000-0000-000000000000}"/>
          </ac:spMkLst>
        </pc:spChg>
      </pc:sldChg>
      <pc:sldChg chg="modSp mod">
        <pc:chgData name="Lingling" userId="bec88c83-2b4b-4a43-bc36-807232f649f0" providerId="ADAL" clId="{6CF37FC8-971D-470F-AC09-B204BCBEE5A1}" dt="2021-07-29T12:06:57.699" v="35" actId="20577"/>
        <pc:sldMkLst>
          <pc:docMk/>
          <pc:sldMk cId="0" sldId="264"/>
        </pc:sldMkLst>
        <pc:spChg chg="mod">
          <ac:chgData name="Lingling" userId="bec88c83-2b4b-4a43-bc36-807232f649f0" providerId="ADAL" clId="{6CF37FC8-971D-470F-AC09-B204BCBEE5A1}" dt="2021-07-29T12:06:57.699" v="35" actId="20577"/>
          <ac:spMkLst>
            <pc:docMk/>
            <pc:sldMk cId="0" sldId="264"/>
            <ac:spMk id="20" creationId="{00000000-0000-0000-0000-000000000000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67095" y="3321888"/>
            <a:ext cx="6427074" cy="2292150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134190" y="6059593"/>
            <a:ext cx="5292884" cy="2732758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5481916" y="428235"/>
            <a:ext cx="1701284" cy="9124045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378065" y="428235"/>
            <a:ext cx="4977831" cy="9124045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97288" y="6871501"/>
            <a:ext cx="6427074" cy="2123828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97288" y="4532322"/>
            <a:ext cx="6427074" cy="233917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378064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843642" y="2495127"/>
            <a:ext cx="3339558" cy="705715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8064" y="2393641"/>
            <a:ext cx="3340871" cy="99755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78064" y="3391195"/>
            <a:ext cx="3340871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841019" y="2393641"/>
            <a:ext cx="3342183" cy="997554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841019" y="3391195"/>
            <a:ext cx="3342183" cy="6161082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78065" y="425757"/>
            <a:ext cx="2487603" cy="181193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956244" y="425759"/>
            <a:ext cx="4226956" cy="912652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78065" y="2237697"/>
            <a:ext cx="2487603" cy="731458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482060" y="7485380"/>
            <a:ext cx="4536758" cy="88369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482060" y="955475"/>
            <a:ext cx="4536758" cy="641604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482060" y="8369071"/>
            <a:ext cx="4536758" cy="125498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78064" y="428233"/>
            <a:ext cx="6805137" cy="178223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78064" y="2495127"/>
            <a:ext cx="6805137" cy="705715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78065" y="9911199"/>
            <a:ext cx="1764295" cy="569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1/7/30 Friday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583432" y="9911199"/>
            <a:ext cx="2394400" cy="569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5418907" y="9911199"/>
            <a:ext cx="1764295" cy="56932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jpeg"/><Relationship Id="rId3" Type="http://schemas.openxmlformats.org/officeDocument/2006/relationships/image" Target="../media/image3.jpeg"/><Relationship Id="rId7" Type="http://schemas.openxmlformats.org/officeDocument/2006/relationships/image" Target="../media/image7.jpe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6.jpeg"/><Relationship Id="rId11" Type="http://schemas.openxmlformats.org/officeDocument/2006/relationships/image" Target="../media/image11.jpeg"/><Relationship Id="rId5" Type="http://schemas.openxmlformats.org/officeDocument/2006/relationships/image" Target="../media/image5.jpeg"/><Relationship Id="rId10" Type="http://schemas.openxmlformats.org/officeDocument/2006/relationships/image" Target="../media/image10.jpeg"/><Relationship Id="rId4" Type="http://schemas.openxmlformats.org/officeDocument/2006/relationships/image" Target="../media/image4.jpeg"/><Relationship Id="rId9" Type="http://schemas.openxmlformats.org/officeDocument/2006/relationships/image" Target="../media/image9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图片 12"/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/>
          <a:stretch>
            <a:fillRect/>
          </a:stretch>
        </p:blipFill>
        <p:spPr>
          <a:xfrm>
            <a:off x="1548383" y="1602284"/>
            <a:ext cx="4680520" cy="1765360"/>
          </a:xfrm>
          <a:prstGeom prst="rect">
            <a:avLst/>
          </a:prstGeom>
          <a:noFill/>
          <a:ln>
            <a:noFill/>
          </a:ln>
        </p:spPr>
      </p:pic>
      <p:sp>
        <p:nvSpPr>
          <p:cNvPr id="14" name="TextBox 13"/>
          <p:cNvSpPr txBox="1"/>
          <p:nvPr/>
        </p:nvSpPr>
        <p:spPr>
          <a:xfrm>
            <a:off x="396255" y="4626620"/>
            <a:ext cx="6696744" cy="10772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808038" indent="-808038"/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ure S1 The agarose gel electrophoresis of PCR products of the reference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  genes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rom </a:t>
            </a:r>
            <a:r>
              <a:rPr lang="en-US" altLang="zh-CN" sz="1600" i="1" dirty="0" err="1">
                <a:latin typeface="Times New Roman" pitchFamily="18" charset="0"/>
                <a:cs typeface="Times New Roman" pitchFamily="18" charset="0"/>
              </a:rPr>
              <a:t>Agasicles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i="1" dirty="0" err="1">
                <a:latin typeface="Times New Roman" pitchFamily="18" charset="0"/>
                <a:cs typeface="Times New Roman" pitchFamily="18" charset="0"/>
              </a:rPr>
              <a:t>hygrophila</a:t>
            </a:r>
            <a:endParaRPr lang="zh-CN" altLang="zh-CN" sz="16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Note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：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1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ACTIN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  2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-ELF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   3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SDHA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4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TUBULIN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5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TBP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endParaRPr lang="en-US" altLang="zh-CN" sz="1600" dirty="0">
              <a:latin typeface="Times New Roman" pitchFamily="18" charset="0"/>
              <a:cs typeface="Times New Roman" pitchFamily="18" charset="0"/>
            </a:endParaRPr>
          </a:p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           6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GAPDH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7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PL32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8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PS20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9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PL13a</a:t>
            </a:r>
            <a:r>
              <a:rPr lang="zh-CN" altLang="zh-CN" sz="1600" dirty="0">
                <a:latin typeface="Times New Roman" pitchFamily="18" charset="0"/>
                <a:cs typeface="Times New Roman" pitchFamily="18" charset="0"/>
              </a:rPr>
              <a:t>；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 10-</a:t>
            </a:r>
            <a:r>
              <a:rPr lang="en-US" altLang="zh-CN" sz="1600" i="1" dirty="0">
                <a:latin typeface="Times New Roman" pitchFamily="18" charset="0"/>
                <a:cs typeface="Times New Roman" pitchFamily="18" charset="0"/>
              </a:rPr>
              <a:t>RPS13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612279" y="810196"/>
            <a:ext cx="194421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S1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455" y="1170235"/>
            <a:ext cx="1577369" cy="2160000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271" y="1142560"/>
            <a:ext cx="1577369" cy="2160000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0631" y="1170235"/>
            <a:ext cx="1577369" cy="2160000"/>
          </a:xfrm>
          <a:prstGeom prst="rect">
            <a:avLst/>
          </a:prstGeom>
        </p:spPr>
      </p:pic>
      <p:pic>
        <p:nvPicPr>
          <p:cNvPr id="8" name="图片 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7078" y="3618507"/>
            <a:ext cx="1577369" cy="2160000"/>
          </a:xfrm>
          <a:prstGeom prst="rect">
            <a:avLst/>
          </a:prstGeom>
        </p:spPr>
      </p:pic>
      <p:pic>
        <p:nvPicPr>
          <p:cNvPr id="9" name="图片 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6815" y="1170235"/>
            <a:ext cx="1577369" cy="2160000"/>
          </a:xfrm>
          <a:prstGeom prst="rect">
            <a:avLst/>
          </a:prstGeom>
        </p:spPr>
      </p:pic>
      <p:pic>
        <p:nvPicPr>
          <p:cNvPr id="10" name="图片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96455" y="3618508"/>
            <a:ext cx="1577368" cy="2160000"/>
          </a:xfrm>
          <a:prstGeom prst="rect">
            <a:avLst/>
          </a:prstGeom>
        </p:spPr>
      </p:pic>
      <p:sp>
        <p:nvSpPr>
          <p:cNvPr id="11" name="TextBox 10"/>
          <p:cNvSpPr txBox="1"/>
          <p:nvPr/>
        </p:nvSpPr>
        <p:spPr>
          <a:xfrm>
            <a:off x="396255" y="234132"/>
            <a:ext cx="201622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Times New Roman" pitchFamily="18" charset="0"/>
                <a:cs typeface="Times New Roman" pitchFamily="18" charset="0"/>
              </a:rPr>
              <a:t>Figure S2</a:t>
            </a:r>
            <a:endParaRPr lang="zh-CN" altLang="en-US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463" y="5922764"/>
            <a:ext cx="1577368" cy="216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80631" y="3618508"/>
            <a:ext cx="1577368" cy="2160000"/>
          </a:xfrm>
          <a:prstGeom prst="rect">
            <a:avLst/>
          </a:prstGeom>
        </p:spPr>
      </p:pic>
      <p:pic>
        <p:nvPicPr>
          <p:cNvPr id="18" name="图片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36815" y="3618508"/>
            <a:ext cx="1577368" cy="2160000"/>
          </a:xfrm>
          <a:prstGeom prst="rect">
            <a:avLst/>
          </a:prstGeom>
        </p:spPr>
      </p:pic>
      <p:pic>
        <p:nvPicPr>
          <p:cNvPr id="19" name="图片 18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0271" y="5922764"/>
            <a:ext cx="1577368" cy="2160000"/>
          </a:xfrm>
          <a:prstGeom prst="rect">
            <a:avLst/>
          </a:prstGeom>
        </p:spPr>
      </p:pic>
      <p:sp>
        <p:nvSpPr>
          <p:cNvPr id="20" name="矩形 19"/>
          <p:cNvSpPr/>
          <p:nvPr/>
        </p:nvSpPr>
        <p:spPr>
          <a:xfrm>
            <a:off x="540271" y="8371036"/>
            <a:ext cx="6840760" cy="33855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Fig. S2. Melting curve of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the </a:t>
            </a:r>
            <a:r>
              <a:rPr lang="en-US" altLang="zh-CN" sz="1600" dirty="0" err="1">
                <a:latin typeface="Times New Roman" pitchFamily="18" charset="0"/>
                <a:cs typeface="Times New Roman" pitchFamily="18" charset="0"/>
              </a:rPr>
              <a:t>PCRs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altLang="zh-CN" sz="1600" dirty="0" smtClean="0">
                <a:latin typeface="Times New Roman" pitchFamily="18" charset="0"/>
                <a:cs typeface="Times New Roman" pitchFamily="18" charset="0"/>
              </a:rPr>
              <a:t>for </a:t>
            </a:r>
            <a:r>
              <a:rPr lang="en-US" altLang="zh-CN" sz="1600" dirty="0">
                <a:latin typeface="Times New Roman" pitchFamily="18" charset="0"/>
                <a:cs typeface="Times New Roman" pitchFamily="18" charset="0"/>
              </a:rPr>
              <a:t>the ten candidate reference genes</a:t>
            </a:r>
            <a:endParaRPr lang="zh-CN" altLang="en-US" sz="16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26</TotalTime>
  <Words>57</Words>
  <Application>Microsoft Office PowerPoint</Application>
  <PresentationFormat>自定义</PresentationFormat>
  <Paragraphs>6</Paragraphs>
  <Slides>2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3" baseType="lpstr">
      <vt:lpstr>Office 主题</vt:lpstr>
      <vt:lpstr>幻灯片 1</vt:lpstr>
      <vt:lpstr>幻灯片 2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yanqong_guo</dc:creator>
  <cp:lastModifiedBy>Administrator</cp:lastModifiedBy>
  <cp:revision>60</cp:revision>
  <dcterms:created xsi:type="dcterms:W3CDTF">2016-05-09T03:58:00Z</dcterms:created>
  <dcterms:modified xsi:type="dcterms:W3CDTF">2021-07-30T16:24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1.0.8567</vt:lpwstr>
  </property>
</Properties>
</file>